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7346E-BE4C-482A-A8AF-2E08F71127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38197A-4B54-4E6A-B932-744E4D70C2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3CF8E7-C2B8-4BDE-86C7-1038FA8FA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EE3BD3-6110-41E7-8807-AC2074BF7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06306-C515-4B4A-BF46-DA06153FA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693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AB0E1-014A-49E3-86AC-A3CA39813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9CB16-6140-456A-8A10-5FF502DF4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392E1-B4C0-4B6D-8550-4B9660413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E2C053-31A6-47B2-80BE-62EC08AE8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09284-B795-4A31-BFC0-3A332A613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097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CAEF8A-516B-4949-8D3E-58DE02F3EA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4A3F3-B6FB-462D-94A7-5345D268B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DD27A3-1D80-47F1-BD76-AF91D5FFB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E450CE-9D7B-4142-BA5E-97D64E7F2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E91349-E277-4068-AA74-2E906CD72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792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9EBDA-54C7-49BC-8E86-2DF0C541A1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82CB4D-0EDC-47BD-8A6E-9767DBC82F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5E46BF-368C-417C-982B-E378CFDE9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C71856-27F2-463F-8AC9-E54FE0E10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B35774-B682-4E2D-8E42-C93F254FE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585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C60B82-ADE7-40F3-8646-81623863D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BB17C1-B239-45B0-9522-3A10D1CEBA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280DD3-D338-4A9C-9A0A-66FBD5D8E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E235A6-4203-457A-B4E9-E5FA5A540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5356EF-8FF5-462E-9BB2-842C0F1B4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651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1A7A0-6081-4FF7-B2A5-674EB1E11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795431-A62C-4853-845A-4BFDCCE628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7B9FF9-A79A-4693-91E6-0669370401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9A08B0-149A-4E0D-8CD8-625C1C08F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E792E4-C3FA-4030-A07D-1146E1038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3EC1DD-0B3C-4D60-85AE-EC086DDE4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773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6EAE8B-473B-4078-88AD-C8933DCE31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03AF5F-8E16-41FA-A79E-12E521FE91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512E2C-673C-457B-90D4-23582CF9CE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4C7B65-FBC7-4BBF-BE31-6EAE822838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6F77CC-F284-4EC9-BC6D-6614992B3C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952138-A68D-4103-BBBD-576058FD1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55A4227-28DD-4C92-9B9F-2869E8A9D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78A10-1642-4700-8A43-1E04D98D2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286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76B00-D833-400C-90B6-83823ABDAB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E45EEC-2C14-494C-8DA5-6655FAB70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FE4AFB-500A-48F3-AE76-6C5AEF49C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1B281B-268A-4310-9361-305407E55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4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297C35-7561-487A-932F-E0F683953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4248AC-844C-4911-AC31-FBD1B291E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03CD6FD-A1D4-4327-AF3C-A49510DA4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086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D7D1B-E33E-444E-B948-1EE740B6D1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9479F8-56B7-46A2-8F48-9EE441BA59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97DA7-5A77-4D86-B80A-9FB6DB84CC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3C277B-09DD-42A4-926F-33A15D5D1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763895-07BB-4EAF-9AEA-47E7EFE04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A58002-996A-4DE2-BD91-FBACBB8F3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004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664D8-57A7-4732-9169-4921CED2C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92ABA77-CF6D-4577-9D2E-9EB007E4C6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455669-E00F-4E40-AA95-75B3D360E6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0E6FFD-6DD7-46C7-AE96-1237B9A9B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C804C9-CA09-4DD1-8197-CA7C199DC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4338FF-DD4D-4426-882D-C277AFA3F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930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A37B86-A623-4EED-B7C1-0D0C610AB0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A2A817-C589-4215-94D1-51E4E879B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130DB8-80BC-4949-97FC-22F18E5A99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15C33-3EB7-4B13-A532-044B6A73A059}" type="datetimeFigureOut">
              <a:rPr lang="en-US" smtClean="0"/>
              <a:t>8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D9AB8C-EEDE-4A00-A722-3350A01EF2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3923F-7D81-4299-801D-A37D7383E3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D7D06-779A-41A6-8807-31A95A027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950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B1BB376-7F8F-421E-9679-99022952E1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80052" y="0"/>
            <a:ext cx="10031896" cy="55732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B3D5097-EF18-42E5-8855-EDE3F0C043FE}"/>
              </a:ext>
            </a:extLst>
          </p:cNvPr>
          <p:cNvSpPr txBox="1"/>
          <p:nvPr/>
        </p:nvSpPr>
        <p:spPr>
          <a:xfrm>
            <a:off x="2027583" y="742122"/>
            <a:ext cx="2597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GLM + PCA, control</a:t>
            </a:r>
          </a:p>
        </p:txBody>
      </p:sp>
    </p:spTree>
    <p:extLst>
      <p:ext uri="{BB962C8B-B14F-4D97-AF65-F5344CB8AC3E}">
        <p14:creationId xmlns:p14="http://schemas.microsoft.com/office/powerpoint/2010/main" val="2450864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A7AC1D0-1E33-471B-B2DB-12DBDABA33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54155" y="-1"/>
            <a:ext cx="10230680" cy="568371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4F2B9C7-3980-448D-B900-901175FA4C4F}"/>
              </a:ext>
            </a:extLst>
          </p:cNvPr>
          <p:cNvSpPr txBox="1"/>
          <p:nvPr/>
        </p:nvSpPr>
        <p:spPr>
          <a:xfrm>
            <a:off x="2027582" y="742122"/>
            <a:ext cx="3087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GLM + PCA,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ility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5022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E383DEC-09DC-4372-9581-2909033D1F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2196" y="0"/>
            <a:ext cx="10187608" cy="56597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2052BBD-9F4F-4F9E-8909-E28BF123781C}"/>
              </a:ext>
            </a:extLst>
          </p:cNvPr>
          <p:cNvSpPr txBox="1"/>
          <p:nvPr/>
        </p:nvSpPr>
        <p:spPr>
          <a:xfrm>
            <a:off x="2027583" y="742122"/>
            <a:ext cx="3101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MLM + kinship, control</a:t>
            </a:r>
          </a:p>
        </p:txBody>
      </p:sp>
    </p:spTree>
    <p:extLst>
      <p:ext uri="{BB962C8B-B14F-4D97-AF65-F5344CB8AC3E}">
        <p14:creationId xmlns:p14="http://schemas.microsoft.com/office/powerpoint/2010/main" val="21482128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BE23700-9E7A-4F20-A0E0-5313356445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3731" y="0"/>
            <a:ext cx="9780105" cy="543339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81A7CF8-EB2A-40AE-BCA5-823811D54F72}"/>
              </a:ext>
            </a:extLst>
          </p:cNvPr>
          <p:cNvSpPr txBox="1"/>
          <p:nvPr/>
        </p:nvSpPr>
        <p:spPr>
          <a:xfrm>
            <a:off x="2027583" y="742122"/>
            <a:ext cx="3101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MLM + kinship, salinit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38139A-125C-41C2-89CC-22B29DF2AE61}"/>
              </a:ext>
            </a:extLst>
          </p:cNvPr>
          <p:cNvSpPr txBox="1"/>
          <p:nvPr/>
        </p:nvSpPr>
        <p:spPr>
          <a:xfrm>
            <a:off x="318052" y="5976730"/>
            <a:ext cx="116089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: QQ plots resulted from GWAS using GLM+PCA (a and b) and MLM + Kinship (c and d) for the physiological traits scored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1587027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hmed Sallam</dc:creator>
  <cp:lastModifiedBy>Dr. Ahmed Sallam</cp:lastModifiedBy>
  <cp:revision>3</cp:revision>
  <dcterms:created xsi:type="dcterms:W3CDTF">2022-04-14T00:49:41Z</dcterms:created>
  <dcterms:modified xsi:type="dcterms:W3CDTF">2022-08-15T14:16:36Z</dcterms:modified>
</cp:coreProperties>
</file>